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80" d="100"/>
          <a:sy n="80" d="100"/>
        </p:scale>
        <p:origin x="1710" y="-15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7F1D3-0AC8-4ECC-8EC5-8E6F2BCBCDED}" type="datetimeFigureOut">
              <a:rPr lang="en-GB" smtClean="0"/>
              <a:t>2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617D3-C5ED-4D3F-8DAD-688844F1A7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0782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7F1D3-0AC8-4ECC-8EC5-8E6F2BCBCDED}" type="datetimeFigureOut">
              <a:rPr lang="en-GB" smtClean="0"/>
              <a:t>2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617D3-C5ED-4D3F-8DAD-688844F1A7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7903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7F1D3-0AC8-4ECC-8EC5-8E6F2BCBCDED}" type="datetimeFigureOut">
              <a:rPr lang="en-GB" smtClean="0"/>
              <a:t>2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617D3-C5ED-4D3F-8DAD-688844F1A7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8860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7F1D3-0AC8-4ECC-8EC5-8E6F2BCBCDED}" type="datetimeFigureOut">
              <a:rPr lang="en-GB" smtClean="0"/>
              <a:t>2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617D3-C5ED-4D3F-8DAD-688844F1A7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6722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7F1D3-0AC8-4ECC-8EC5-8E6F2BCBCDED}" type="datetimeFigureOut">
              <a:rPr lang="en-GB" smtClean="0"/>
              <a:t>2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617D3-C5ED-4D3F-8DAD-688844F1A7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5153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7F1D3-0AC8-4ECC-8EC5-8E6F2BCBCDED}" type="datetimeFigureOut">
              <a:rPr lang="en-GB" smtClean="0"/>
              <a:t>24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617D3-C5ED-4D3F-8DAD-688844F1A7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4998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7F1D3-0AC8-4ECC-8EC5-8E6F2BCBCDED}" type="datetimeFigureOut">
              <a:rPr lang="en-GB" smtClean="0"/>
              <a:t>24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617D3-C5ED-4D3F-8DAD-688844F1A7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07173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7F1D3-0AC8-4ECC-8EC5-8E6F2BCBCDED}" type="datetimeFigureOut">
              <a:rPr lang="en-GB" smtClean="0"/>
              <a:t>24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617D3-C5ED-4D3F-8DAD-688844F1A7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31137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7F1D3-0AC8-4ECC-8EC5-8E6F2BCBCDED}" type="datetimeFigureOut">
              <a:rPr lang="en-GB" smtClean="0"/>
              <a:t>24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617D3-C5ED-4D3F-8DAD-688844F1A7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6303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7F1D3-0AC8-4ECC-8EC5-8E6F2BCBCDED}" type="datetimeFigureOut">
              <a:rPr lang="en-GB" smtClean="0"/>
              <a:t>24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617D3-C5ED-4D3F-8DAD-688844F1A7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97304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7F1D3-0AC8-4ECC-8EC5-8E6F2BCBCDED}" type="datetimeFigureOut">
              <a:rPr lang="en-GB" smtClean="0"/>
              <a:t>24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1617D3-C5ED-4D3F-8DAD-688844F1A7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8881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7F1D3-0AC8-4ECC-8EC5-8E6F2BCBCDED}" type="datetimeFigureOut">
              <a:rPr lang="en-GB" smtClean="0"/>
              <a:t>2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1617D3-C5ED-4D3F-8DAD-688844F1A76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314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447726" y="154910"/>
            <a:ext cx="3376495" cy="2651912"/>
            <a:chOff x="-3721944" y="2109265"/>
            <a:chExt cx="3376495" cy="2651912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3585449" y="2168858"/>
              <a:ext cx="3240000" cy="2592319"/>
            </a:xfrm>
            <a:prstGeom prst="rect">
              <a:avLst/>
            </a:prstGeom>
          </p:spPr>
        </p:pic>
        <p:sp>
          <p:nvSpPr>
            <p:cNvPr id="33" name="TextBox 32"/>
            <p:cNvSpPr txBox="1"/>
            <p:nvPr/>
          </p:nvSpPr>
          <p:spPr>
            <a:xfrm>
              <a:off x="-2820062" y="4220841"/>
              <a:ext cx="16590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Log Rank=16.150, p=0.00005</a:t>
              </a:r>
              <a:endParaRPr lang="en-GB" sz="800" baseline="300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-2327672" y="3153881"/>
              <a:ext cx="4952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n=185</a:t>
              </a:r>
              <a:endParaRPr lang="en-GB" sz="800" baseline="30000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-1846434" y="2628959"/>
              <a:ext cx="4952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n=893</a:t>
              </a:r>
              <a:endParaRPr lang="en-GB" sz="800" baseline="300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-3250067" y="2355625"/>
              <a:ext cx="208907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b="1" dirty="0" smtClean="0"/>
                <a:t>Discovery set</a:t>
              </a:r>
              <a:endParaRPr lang="en-GB" sz="1050" b="1" baseline="30000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-3721944" y="2109265"/>
              <a:ext cx="3838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/>
                <a:t>A</a:t>
              </a:r>
              <a:endParaRPr lang="en-GB" b="1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-3244466" y="4168746"/>
              <a:ext cx="81750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 smtClean="0"/>
                <a:t>protein</a:t>
              </a:r>
              <a:endParaRPr lang="en-GB" sz="1050" b="1" baseline="30000" dirty="0"/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3812120" y="154910"/>
            <a:ext cx="3380911" cy="2658474"/>
            <a:chOff x="-4003113" y="1717416"/>
            <a:chExt cx="3380911" cy="2658474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-3862202" y="1783571"/>
              <a:ext cx="3240000" cy="2592319"/>
            </a:xfrm>
            <a:prstGeom prst="rect">
              <a:avLst/>
            </a:prstGeom>
          </p:spPr>
        </p:pic>
        <p:sp>
          <p:nvSpPr>
            <p:cNvPr id="39" name="TextBox 38"/>
            <p:cNvSpPr txBox="1"/>
            <p:nvPr/>
          </p:nvSpPr>
          <p:spPr>
            <a:xfrm>
              <a:off x="-3101231" y="3828992"/>
              <a:ext cx="16590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Log Rank=14.114, p=0.0001</a:t>
              </a:r>
              <a:endParaRPr lang="en-GB" sz="800" baseline="30000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-2360109" y="2596631"/>
              <a:ext cx="4952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n=267</a:t>
              </a:r>
              <a:endParaRPr lang="en-GB" sz="800" baseline="300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-2112490" y="2126784"/>
              <a:ext cx="4952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n=1264</a:t>
              </a:r>
              <a:endParaRPr lang="en-GB" sz="800" baseline="30000" dirty="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-3531236" y="1963776"/>
              <a:ext cx="208907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b="1" dirty="0" smtClean="0"/>
                <a:t>Validation set</a:t>
              </a:r>
              <a:endParaRPr lang="en-GB" sz="1050" b="1" baseline="300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-4003113" y="1717416"/>
              <a:ext cx="3838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B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-3525635" y="3776897"/>
              <a:ext cx="81750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 smtClean="0"/>
                <a:t>protein</a:t>
              </a:r>
              <a:endParaRPr lang="en-GB" sz="1050" b="1" baseline="30000" dirty="0"/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447726" y="3328861"/>
            <a:ext cx="3380264" cy="2671779"/>
            <a:chOff x="-4107818" y="3385558"/>
            <a:chExt cx="3380264" cy="2671779"/>
          </a:xfrm>
        </p:grpSpPr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-3967554" y="3465018"/>
              <a:ext cx="3240000" cy="2592319"/>
            </a:xfrm>
            <a:prstGeom prst="rect">
              <a:avLst/>
            </a:prstGeom>
          </p:spPr>
        </p:pic>
        <p:sp>
          <p:nvSpPr>
            <p:cNvPr id="46" name="TextBox 45"/>
            <p:cNvSpPr txBox="1"/>
            <p:nvPr/>
          </p:nvSpPr>
          <p:spPr>
            <a:xfrm>
              <a:off x="-3205936" y="5513760"/>
              <a:ext cx="16590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Log Rank=0.764, p=0.382</a:t>
              </a:r>
              <a:endParaRPr lang="en-GB" sz="800" baseline="300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-2057693" y="3938799"/>
              <a:ext cx="4952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n=971</a:t>
              </a:r>
              <a:endParaRPr lang="en-GB" sz="800" baseline="300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-2192606" y="3716557"/>
              <a:ext cx="4952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n=22</a:t>
              </a:r>
              <a:endParaRPr lang="en-GB" sz="800" baseline="300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-3661692" y="4089334"/>
              <a:ext cx="208907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b="1" dirty="0" smtClean="0"/>
                <a:t>ER+ low </a:t>
              </a:r>
              <a:r>
                <a:rPr lang="en-GB" sz="1050" b="1" dirty="0"/>
                <a:t>p</a:t>
              </a:r>
              <a:r>
                <a:rPr lang="en-GB" sz="1050" b="1" dirty="0" smtClean="0"/>
                <a:t>roliferation</a:t>
              </a:r>
              <a:endParaRPr lang="en-GB" sz="1050" b="1" baseline="300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-4107818" y="3385558"/>
              <a:ext cx="3838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C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-3630340" y="5469978"/>
              <a:ext cx="81750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 smtClean="0"/>
                <a:t>protein</a:t>
              </a:r>
              <a:endParaRPr lang="en-GB" sz="1050" b="1" baseline="30000" dirty="0"/>
            </a:p>
          </p:txBody>
        </p:sp>
      </p:grpSp>
      <p:grpSp>
        <p:nvGrpSpPr>
          <p:cNvPr id="60" name="Group 59"/>
          <p:cNvGrpSpPr/>
          <p:nvPr/>
        </p:nvGrpSpPr>
        <p:grpSpPr>
          <a:xfrm>
            <a:off x="3812120" y="3328861"/>
            <a:ext cx="3379896" cy="2660026"/>
            <a:chOff x="-4010418" y="1543178"/>
            <a:chExt cx="3379896" cy="2660026"/>
          </a:xfrm>
        </p:grpSpPr>
        <p:pic>
          <p:nvPicPr>
            <p:cNvPr id="53" name="Picture 5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-3870522" y="1610885"/>
              <a:ext cx="3240000" cy="2592319"/>
            </a:xfrm>
            <a:prstGeom prst="rect">
              <a:avLst/>
            </a:prstGeom>
          </p:spPr>
        </p:pic>
        <p:sp>
          <p:nvSpPr>
            <p:cNvPr id="54" name="TextBox 53"/>
            <p:cNvSpPr txBox="1"/>
            <p:nvPr/>
          </p:nvSpPr>
          <p:spPr>
            <a:xfrm>
              <a:off x="-3108536" y="3654754"/>
              <a:ext cx="16590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Log Rank=4.606, p=0.030</a:t>
              </a:r>
              <a:endParaRPr lang="en-GB" sz="800" baseline="300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-2616146" y="2587794"/>
              <a:ext cx="4952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n=125</a:t>
              </a:r>
              <a:endParaRPr lang="en-GB" sz="800" baseline="300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-2195714" y="2054314"/>
              <a:ext cx="4952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n=652</a:t>
              </a:r>
              <a:endParaRPr lang="en-GB" sz="800" baseline="300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-3538541" y="1789538"/>
              <a:ext cx="208907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b="1" dirty="0" smtClean="0"/>
                <a:t>ER+ high </a:t>
              </a:r>
              <a:r>
                <a:rPr lang="en-GB" sz="1050" b="1" dirty="0"/>
                <a:t>p</a:t>
              </a:r>
              <a:r>
                <a:rPr lang="en-GB" sz="1050" b="1" dirty="0" smtClean="0"/>
                <a:t>roliferation</a:t>
              </a:r>
              <a:endParaRPr lang="en-GB" sz="1050" b="1" baseline="300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-4010418" y="1543178"/>
              <a:ext cx="3838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D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-3532940" y="3619285"/>
              <a:ext cx="81750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 smtClean="0"/>
                <a:t>protein</a:t>
              </a:r>
              <a:endParaRPr lang="en-GB" sz="1050" b="1" baseline="30000" dirty="0"/>
            </a:p>
          </p:txBody>
        </p:sp>
      </p:grpSp>
      <p:grpSp>
        <p:nvGrpSpPr>
          <p:cNvPr id="73" name="Group 72"/>
          <p:cNvGrpSpPr/>
          <p:nvPr/>
        </p:nvGrpSpPr>
        <p:grpSpPr>
          <a:xfrm>
            <a:off x="447726" y="6420260"/>
            <a:ext cx="3374088" cy="2667162"/>
            <a:chOff x="-3710840" y="6751548"/>
            <a:chExt cx="3374088" cy="2667162"/>
          </a:xfrm>
        </p:grpSpPr>
        <p:pic>
          <p:nvPicPr>
            <p:cNvPr id="61" name="Picture 60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-3576752" y="6826391"/>
              <a:ext cx="3240000" cy="2592319"/>
            </a:xfrm>
            <a:prstGeom prst="rect">
              <a:avLst/>
            </a:prstGeom>
          </p:spPr>
        </p:pic>
        <p:sp>
          <p:nvSpPr>
            <p:cNvPr id="67" name="TextBox 66"/>
            <p:cNvSpPr txBox="1"/>
            <p:nvPr/>
          </p:nvSpPr>
          <p:spPr>
            <a:xfrm>
              <a:off x="-2808958" y="8863124"/>
              <a:ext cx="16590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Log Rank=1.037, p=0.308</a:t>
              </a:r>
              <a:endParaRPr lang="en-GB" sz="800" baseline="30000" dirty="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-2330567" y="7734308"/>
              <a:ext cx="4952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n=206</a:t>
              </a:r>
              <a:endParaRPr lang="en-GB" sz="800" baseline="30000" dirty="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-1835330" y="7337746"/>
              <a:ext cx="4952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n=194</a:t>
              </a:r>
              <a:endParaRPr lang="en-GB" sz="800" baseline="30000" dirty="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-3238963" y="6997908"/>
              <a:ext cx="208907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b="1" dirty="0" smtClean="0"/>
                <a:t>Triple Negative</a:t>
              </a:r>
              <a:endParaRPr lang="en-GB" sz="1050" b="1" baseline="30000" dirty="0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-3710840" y="6751548"/>
              <a:ext cx="3838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E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-3233362" y="8835968"/>
              <a:ext cx="81750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 smtClean="0"/>
                <a:t>protein</a:t>
              </a:r>
              <a:endParaRPr lang="en-GB" sz="1050" b="1" baseline="30000" dirty="0"/>
            </a:p>
          </p:txBody>
        </p:sp>
      </p:grpSp>
      <p:grpSp>
        <p:nvGrpSpPr>
          <p:cNvPr id="81" name="Group 80"/>
          <p:cNvGrpSpPr/>
          <p:nvPr/>
        </p:nvGrpSpPr>
        <p:grpSpPr>
          <a:xfrm>
            <a:off x="3812120" y="6420260"/>
            <a:ext cx="3371799" cy="2668619"/>
            <a:chOff x="7457721" y="5316049"/>
            <a:chExt cx="3371799" cy="2668619"/>
          </a:xfrm>
        </p:grpSpPr>
        <p:pic>
          <p:nvPicPr>
            <p:cNvPr id="74" name="Picture 7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589520" y="5392349"/>
              <a:ext cx="3240000" cy="2592319"/>
            </a:xfrm>
            <a:prstGeom prst="rect">
              <a:avLst/>
            </a:prstGeom>
          </p:spPr>
        </p:pic>
        <p:sp>
          <p:nvSpPr>
            <p:cNvPr id="75" name="TextBox 74"/>
            <p:cNvSpPr txBox="1"/>
            <p:nvPr/>
          </p:nvSpPr>
          <p:spPr>
            <a:xfrm>
              <a:off x="8359603" y="7444251"/>
              <a:ext cx="16590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Log Rank=1.584, p=0.208</a:t>
              </a:r>
              <a:endParaRPr lang="en-GB" sz="800" baseline="30000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8726516" y="6517991"/>
              <a:ext cx="4952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n=73</a:t>
              </a:r>
              <a:endParaRPr lang="en-GB" sz="800" baseline="30000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9189137" y="6074387"/>
              <a:ext cx="4952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800" dirty="0" smtClean="0"/>
                <a:t>n=180</a:t>
              </a:r>
              <a:endParaRPr lang="en-GB" sz="800" baseline="30000" dirty="0"/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7929598" y="5562409"/>
              <a:ext cx="208907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050" b="1" dirty="0" smtClean="0"/>
                <a:t>HER2+</a:t>
              </a:r>
              <a:endParaRPr lang="en-GB" sz="1050" b="1" baseline="30000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7457721" y="5316049"/>
              <a:ext cx="38389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F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7935199" y="7400469"/>
              <a:ext cx="81750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50" b="1" dirty="0" smtClean="0"/>
                <a:t>protein</a:t>
              </a:r>
              <a:endParaRPr lang="en-GB" sz="1050" b="1" baseline="30000" dirty="0"/>
            </a:p>
          </p:txBody>
        </p:sp>
      </p:grpSp>
      <p:graphicFrame>
        <p:nvGraphicFramePr>
          <p:cNvPr id="82" name="Table 8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5582203"/>
              </p:ext>
            </p:extLst>
          </p:nvPr>
        </p:nvGraphicFramePr>
        <p:xfrm>
          <a:off x="123853" y="2847180"/>
          <a:ext cx="2973070" cy="260858"/>
        </p:xfrm>
        <a:graphic>
          <a:graphicData uri="http://schemas.openxmlformats.org/drawingml/2006/table">
            <a:tbl>
              <a:tblPr firstRow="1" firstCol="1" bandRow="1"/>
              <a:tblGrid>
                <a:gridCol w="77216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3048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9781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33782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9210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0099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28930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33845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ow SLC7A5 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9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35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7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0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5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01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85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igh SLC7A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8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9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31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9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1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graphicFrame>
        <p:nvGraphicFramePr>
          <p:cNvPr id="83" name="Table 8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0311515"/>
              </p:ext>
            </p:extLst>
          </p:nvPr>
        </p:nvGraphicFramePr>
        <p:xfrm>
          <a:off x="3597125" y="2847180"/>
          <a:ext cx="3586794" cy="260858"/>
        </p:xfrm>
        <a:graphic>
          <a:graphicData uri="http://schemas.openxmlformats.org/drawingml/2006/table">
            <a:tbl>
              <a:tblPr firstRow="1" firstCol="1" bandRow="1"/>
              <a:tblGrid>
                <a:gridCol w="66076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349082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35744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34913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349134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24197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07571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889462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ow SLC7A5 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6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2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4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77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7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9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6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igh SLC7A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67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41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1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8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6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graphicFrame>
        <p:nvGraphicFramePr>
          <p:cNvPr id="84" name="Table 8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9288899"/>
              </p:ext>
            </p:extLst>
          </p:nvPr>
        </p:nvGraphicFramePr>
        <p:xfrm>
          <a:off x="123853" y="6009200"/>
          <a:ext cx="2973070" cy="260858"/>
        </p:xfrm>
        <a:graphic>
          <a:graphicData uri="http://schemas.openxmlformats.org/drawingml/2006/table">
            <a:tbl>
              <a:tblPr firstRow="1" firstCol="1" bandRow="1"/>
              <a:tblGrid>
                <a:gridCol w="77216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3048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9781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33782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9210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0099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28930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33845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ow SLC7A5 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71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57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2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87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2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57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1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igh SLC7A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1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graphicFrame>
        <p:nvGraphicFramePr>
          <p:cNvPr id="85" name="Table 8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953692"/>
              </p:ext>
            </p:extLst>
          </p:nvPr>
        </p:nvGraphicFramePr>
        <p:xfrm>
          <a:off x="3505682" y="6009200"/>
          <a:ext cx="2973070" cy="260858"/>
        </p:xfrm>
        <a:graphic>
          <a:graphicData uri="http://schemas.openxmlformats.org/drawingml/2006/table">
            <a:tbl>
              <a:tblPr firstRow="1" firstCol="1" bandRow="1"/>
              <a:tblGrid>
                <a:gridCol w="77216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3048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9781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33782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9210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0099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28930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33845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ow SLC7A5 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5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1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7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2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6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1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4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igh SLC7A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5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7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5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graphicFrame>
        <p:nvGraphicFramePr>
          <p:cNvPr id="86" name="Table 8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7044921"/>
              </p:ext>
            </p:extLst>
          </p:nvPr>
        </p:nvGraphicFramePr>
        <p:xfrm>
          <a:off x="123853" y="9217505"/>
          <a:ext cx="2973070" cy="260858"/>
        </p:xfrm>
        <a:graphic>
          <a:graphicData uri="http://schemas.openxmlformats.org/drawingml/2006/table">
            <a:tbl>
              <a:tblPr firstRow="1" firstCol="1" bandRow="1"/>
              <a:tblGrid>
                <a:gridCol w="77216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3048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9781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33782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9210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0099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28930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33845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ow SLC7A5 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8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3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igh SLC7A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9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2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37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graphicFrame>
        <p:nvGraphicFramePr>
          <p:cNvPr id="87" name="Table 8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7062257"/>
              </p:ext>
            </p:extLst>
          </p:nvPr>
        </p:nvGraphicFramePr>
        <p:xfrm>
          <a:off x="3505682" y="9217505"/>
          <a:ext cx="2973070" cy="260858"/>
        </p:xfrm>
        <a:graphic>
          <a:graphicData uri="http://schemas.openxmlformats.org/drawingml/2006/table">
            <a:tbl>
              <a:tblPr firstRow="1" firstCol="1" bandRow="1"/>
              <a:tblGrid>
                <a:gridCol w="77216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3048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9781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33782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9210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0099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28930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33845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ow SLC7A5 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8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1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7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9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igh SLC7A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9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7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800" dirty="0" smtClean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9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56168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</TotalTime>
  <Words>172</Words>
  <Application>Microsoft Office PowerPoint</Application>
  <PresentationFormat>A4 Paper (210x297 mm)</PresentationFormat>
  <Paragraphs>1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Nottingham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 ansari Rokaya</dc:creator>
  <cp:lastModifiedBy>El ansari Rokaya</cp:lastModifiedBy>
  <cp:revision>7</cp:revision>
  <dcterms:created xsi:type="dcterms:W3CDTF">2018-01-03T15:36:14Z</dcterms:created>
  <dcterms:modified xsi:type="dcterms:W3CDTF">2018-01-24T12:09:30Z</dcterms:modified>
</cp:coreProperties>
</file>